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82296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1" d="100"/>
          <a:sy n="91" d="100"/>
        </p:scale>
        <p:origin x="-888" y="216"/>
      </p:cViewPr>
      <p:guideLst>
        <p:guide orient="horz" pos="259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56511"/>
            <a:ext cx="7772400" cy="176403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663440"/>
            <a:ext cx="6400800" cy="21031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96240"/>
            <a:ext cx="2057400" cy="842581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96240"/>
            <a:ext cx="6019800" cy="842581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288281"/>
            <a:ext cx="7772400" cy="163449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488056"/>
            <a:ext cx="7772400" cy="180022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305050"/>
            <a:ext cx="4038600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305050"/>
            <a:ext cx="4038600" cy="651700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29566"/>
            <a:ext cx="8229600" cy="13716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42136"/>
            <a:ext cx="4040188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609850"/>
            <a:ext cx="4040188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842136"/>
            <a:ext cx="4041775" cy="7677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609850"/>
            <a:ext cx="4041775" cy="474154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27660"/>
            <a:ext cx="3008313" cy="139446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27660"/>
            <a:ext cx="5111750" cy="702373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722120"/>
            <a:ext cx="3008313" cy="562927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760720"/>
            <a:ext cx="5486400" cy="68008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35330"/>
            <a:ext cx="5486400" cy="493776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440806"/>
            <a:ext cx="5486400" cy="96583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29566"/>
            <a:ext cx="8229600" cy="1371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920240"/>
            <a:ext cx="8229600" cy="5431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7627621"/>
            <a:ext cx="2133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B13A5-8D7C-48FD-890E-BDA8321A41E7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7627621"/>
            <a:ext cx="2895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7627621"/>
            <a:ext cx="213360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86CB32-E495-45A5-A381-D8F0B08D57F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>
            <a:grpSpLocks noChangeAspect="1"/>
          </p:cNvGrpSpPr>
          <p:nvPr/>
        </p:nvGrpSpPr>
        <p:grpSpPr>
          <a:xfrm>
            <a:off x="393411" y="228600"/>
            <a:ext cx="8369589" cy="7312967"/>
            <a:chOff x="393411" y="228600"/>
            <a:chExt cx="8369589" cy="7312967"/>
          </a:xfrm>
        </p:grpSpPr>
        <p:grpSp>
          <p:nvGrpSpPr>
            <p:cNvPr id="4" name="Group 3"/>
            <p:cNvGrpSpPr/>
            <p:nvPr/>
          </p:nvGrpSpPr>
          <p:grpSpPr>
            <a:xfrm>
              <a:off x="393411" y="228600"/>
              <a:ext cx="8369589" cy="6144399"/>
              <a:chOff x="164811" y="228600"/>
              <a:chExt cx="8369589" cy="6144399"/>
            </a:xfrm>
          </p:grpSpPr>
          <p:sp>
            <p:nvSpPr>
              <p:cNvPr id="5" name="TextBox 4"/>
              <p:cNvSpPr txBox="1"/>
              <p:nvPr/>
            </p:nvSpPr>
            <p:spPr>
              <a:xfrm rot="16200000">
                <a:off x="-115789" y="4700201"/>
                <a:ext cx="8382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Helvetica" pitchFamily="34" charset="0"/>
                    <a:cs typeface="Helvetica" pitchFamily="34" charset="0"/>
                  </a:rPr>
                  <a:t>Count</a:t>
                </a:r>
                <a:endParaRPr lang="en-US" sz="1200" dirty="0">
                  <a:latin typeface="Helvetica" pitchFamily="34" charset="0"/>
                  <a:cs typeface="Helvetica" pitchFamily="34" charset="0"/>
                </a:endParaRPr>
              </a:p>
            </p:txBody>
          </p:sp>
          <p:grpSp>
            <p:nvGrpSpPr>
              <p:cNvPr id="6" name="Group 20"/>
              <p:cNvGrpSpPr/>
              <p:nvPr/>
            </p:nvGrpSpPr>
            <p:grpSpPr>
              <a:xfrm>
                <a:off x="457200" y="228600"/>
                <a:ext cx="3440504" cy="3276600"/>
                <a:chOff x="457200" y="228600"/>
                <a:chExt cx="3440504" cy="3276600"/>
              </a:xfrm>
            </p:grpSpPr>
            <p:pic>
              <p:nvPicPr>
                <p:cNvPr id="24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 bwMode="auto">
                <a:xfrm>
                  <a:off x="457200" y="381000"/>
                  <a:ext cx="3440504" cy="31242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25" name="TextBox 24"/>
                <p:cNvSpPr txBox="1"/>
                <p:nvPr/>
              </p:nvSpPr>
              <p:spPr>
                <a:xfrm>
                  <a:off x="2209800" y="228600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a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7" name="Group 22"/>
              <p:cNvGrpSpPr/>
              <p:nvPr/>
            </p:nvGrpSpPr>
            <p:grpSpPr>
              <a:xfrm>
                <a:off x="381000" y="3499246"/>
                <a:ext cx="3782291" cy="2870776"/>
                <a:chOff x="381000" y="3426023"/>
                <a:chExt cx="3782291" cy="2870776"/>
              </a:xfrm>
            </p:grpSpPr>
            <p:pic>
              <p:nvPicPr>
                <p:cNvPr id="20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057" t="4122" r="1201" b="5195"/>
                <a:stretch>
                  <a:fillRect/>
                </a:stretch>
              </p:blipFill>
              <p:spPr bwMode="auto">
                <a:xfrm>
                  <a:off x="381000" y="3886200"/>
                  <a:ext cx="3782291" cy="21336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1" name="TextBox 9"/>
                <p:cNvSpPr txBox="1"/>
                <p:nvPr/>
              </p:nvSpPr>
              <p:spPr>
                <a:xfrm>
                  <a:off x="1905000" y="6019800"/>
                  <a:ext cx="762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PPM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22" name="Rectangle 21"/>
                <p:cNvSpPr/>
                <p:nvPr/>
              </p:nvSpPr>
              <p:spPr>
                <a:xfrm>
                  <a:off x="2209800" y="5943600"/>
                  <a:ext cx="304800" cy="762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209800" y="3426023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c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8" name="Group 24"/>
              <p:cNvGrpSpPr/>
              <p:nvPr/>
            </p:nvGrpSpPr>
            <p:grpSpPr>
              <a:xfrm>
                <a:off x="4508211" y="3502223"/>
                <a:ext cx="3873789" cy="2870776"/>
                <a:chOff x="4508211" y="3502223"/>
                <a:chExt cx="3873789" cy="2870776"/>
              </a:xfrm>
            </p:grpSpPr>
            <p:pic>
              <p:nvPicPr>
                <p:cNvPr id="15" name="Picture 3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10" t="4002" r="10921" b="5946"/>
                <a:stretch>
                  <a:fillRect/>
                </a:stretch>
              </p:blipFill>
              <p:spPr bwMode="auto">
                <a:xfrm>
                  <a:off x="4724400" y="3810000"/>
                  <a:ext cx="3657600" cy="225468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6" name="TextBox 15"/>
                <p:cNvSpPr txBox="1"/>
                <p:nvPr/>
              </p:nvSpPr>
              <p:spPr>
                <a:xfrm>
                  <a:off x="6096000" y="6096000"/>
                  <a:ext cx="1143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% CV RT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6200000">
                  <a:off x="4303811" y="4776401"/>
                  <a:ext cx="68580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Count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8" name="Rectangle 17"/>
                <p:cNvSpPr/>
                <p:nvPr/>
              </p:nvSpPr>
              <p:spPr>
                <a:xfrm>
                  <a:off x="6705600" y="6019800"/>
                  <a:ext cx="381000" cy="762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6467290" y="3502223"/>
                  <a:ext cx="26962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d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9" name="Group 25"/>
              <p:cNvGrpSpPr/>
              <p:nvPr/>
            </p:nvGrpSpPr>
            <p:grpSpPr>
              <a:xfrm>
                <a:off x="4203411" y="228600"/>
                <a:ext cx="4330989" cy="3248799"/>
                <a:chOff x="4051011" y="228600"/>
                <a:chExt cx="4330989" cy="3248799"/>
              </a:xfrm>
            </p:grpSpPr>
            <p:grpSp>
              <p:nvGrpSpPr>
                <p:cNvPr id="10" name="Group 21"/>
                <p:cNvGrpSpPr/>
                <p:nvPr/>
              </p:nvGrpSpPr>
              <p:grpSpPr>
                <a:xfrm>
                  <a:off x="4267200" y="228600"/>
                  <a:ext cx="4114800" cy="3248799"/>
                  <a:chOff x="4267200" y="228600"/>
                  <a:chExt cx="4114800" cy="3248799"/>
                </a:xfrm>
              </p:grpSpPr>
              <p:pic>
                <p:nvPicPr>
                  <p:cNvPr id="12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110" t="4460" r="11107" b="7077"/>
                  <a:stretch>
                    <a:fillRect/>
                  </a:stretch>
                </p:blipFill>
                <p:spPr bwMode="auto">
                  <a:xfrm>
                    <a:off x="4267200" y="609600"/>
                    <a:ext cx="4114800" cy="25400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3" name="TextBox 7"/>
                  <p:cNvSpPr txBox="1"/>
                  <p:nvPr/>
                </p:nvSpPr>
                <p:spPr>
                  <a:xfrm>
                    <a:off x="6019800" y="3200400"/>
                    <a:ext cx="99060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Helvetica" pitchFamily="34" charset="0"/>
                        <a:cs typeface="Helvetica" pitchFamily="34" charset="0"/>
                      </a:rPr>
                      <a:t>Replicate 1</a:t>
                    </a:r>
                    <a:endParaRPr lang="en-US" sz="12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6314890" y="228600"/>
                    <a:ext cx="26962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Helvetica" pitchFamily="34" charset="0"/>
                        <a:cs typeface="Helvetica" pitchFamily="34" charset="0"/>
                      </a:rPr>
                      <a:t>b</a:t>
                    </a:r>
                    <a:endParaRPr lang="en-US" sz="1200" dirty="0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  <p:sp>
              <p:nvSpPr>
                <p:cNvPr id="11" name="TextBox 10"/>
                <p:cNvSpPr txBox="1"/>
                <p:nvPr/>
              </p:nvSpPr>
              <p:spPr>
                <a:xfrm rot="16200000">
                  <a:off x="3654851" y="1691560"/>
                  <a:ext cx="1069320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Helvetica" pitchFamily="34" charset="0"/>
                      <a:cs typeface="Helvetica" pitchFamily="34" charset="0"/>
                    </a:rPr>
                    <a:t>Replicate 2</a:t>
                  </a:r>
                  <a:endParaRPr lang="en-US" sz="1200" dirty="0"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</p:grpSp>
        <p:sp>
          <p:nvSpPr>
            <p:cNvPr id="26" name="Rectangle 25"/>
            <p:cNvSpPr/>
            <p:nvPr/>
          </p:nvSpPr>
          <p:spPr>
            <a:xfrm>
              <a:off x="478221" y="6895236"/>
              <a:ext cx="822960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Figure </a:t>
              </a:r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S5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Protein quality control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measurements.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(a)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PCA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plot indicating clear separation between control and inoculated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samples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(b)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reproducibility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of intensity in replicates of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samples;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(c)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majority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of ion counts with less than 3 ppm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error;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and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(d) 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percent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coefficient of variance of retention time (% CV RT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). </a:t>
              </a:r>
              <a:endParaRPr lang="en-US" sz="1200" dirty="0">
                <a:latin typeface="Helvetica" pitchFamily="34" charset="0"/>
                <a:cs typeface="Helvetica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6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shwant Kumar</dc:creator>
  <cp:lastModifiedBy>Bhushan</cp:lastModifiedBy>
  <cp:revision>6</cp:revision>
  <dcterms:created xsi:type="dcterms:W3CDTF">2014-05-21T15:00:59Z</dcterms:created>
  <dcterms:modified xsi:type="dcterms:W3CDTF">2015-09-22T15:01:45Z</dcterms:modified>
</cp:coreProperties>
</file>